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E3682C4-AB1D-4208-AA4B-C0F2713ABACE}" v="1" dt="2025-10-30T16:10:35.2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7E3682C4-AB1D-4208-AA4B-C0F2713ABACE}"/>
    <pc:docChg chg="modSld">
      <pc:chgData name="Semertzidou, Anysia" userId="a7f71f62-1794-4728-88f7-f0b545a7c8aa" providerId="ADAL" clId="{7E3682C4-AB1D-4208-AA4B-C0F2713ABACE}" dt="2025-10-30T16:11:08.300" v="14" actId="113"/>
      <pc:docMkLst>
        <pc:docMk/>
      </pc:docMkLst>
      <pc:sldChg chg="addSp modSp mod">
        <pc:chgData name="Semertzidou, Anysia" userId="a7f71f62-1794-4728-88f7-f0b545a7c8aa" providerId="ADAL" clId="{7E3682C4-AB1D-4208-AA4B-C0F2713ABACE}" dt="2025-10-30T16:11:08.300" v="14" actId="113"/>
        <pc:sldMkLst>
          <pc:docMk/>
          <pc:sldMk cId="3619155556" sldId="256"/>
        </pc:sldMkLst>
        <pc:spChg chg="add mod">
          <ac:chgData name="Semertzidou, Anysia" userId="a7f71f62-1794-4728-88f7-f0b545a7c8aa" providerId="ADAL" clId="{7E3682C4-AB1D-4208-AA4B-C0F2713ABACE}" dt="2025-10-30T16:10:54.016" v="11" actId="113"/>
          <ac:spMkLst>
            <pc:docMk/>
            <pc:sldMk cId="3619155556" sldId="256"/>
            <ac:spMk id="2" creationId="{3D7B8E85-90F1-2181-788E-DD6272EFFE9A}"/>
          </ac:spMkLst>
        </pc:spChg>
        <pc:spChg chg="add mod">
          <ac:chgData name="Semertzidou, Anysia" userId="a7f71f62-1794-4728-88f7-f0b545a7c8aa" providerId="ADAL" clId="{7E3682C4-AB1D-4208-AA4B-C0F2713ABACE}" dt="2025-10-30T16:11:08.300" v="14" actId="113"/>
          <ac:spMkLst>
            <pc:docMk/>
            <pc:sldMk cId="3619155556" sldId="256"/>
            <ac:spMk id="5" creationId="{7B610856-5891-3A71-07F6-EF1AC0DAB15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68B8E-9C69-1EC0-DB0B-198900B424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3EA047-4C7C-CE5F-A94A-1C5DCBD9B0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A5A81B-1E80-41BB-66ED-0960EF1D0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888D9-4CD7-B493-645B-09A1C98BF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B5D611-8AF7-C589-8E89-16A41E4BA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3384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0EF1D-2DDB-7AAB-7445-12806C605E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55E173-EC95-A489-7987-1DFA8276E8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3087EE-9FD9-81DA-2195-5938D2956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E9ACDB-3829-99C2-F100-F3C81DA0E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FEBE56-96FB-C0CF-9162-B41B374C9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188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A12953-8281-A798-9AAA-D37715C6D3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578AC3-04FB-6DCB-DAF5-E7C0E09806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09272-C7C1-E5C4-91C4-217A82EA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6F7FE5-95A4-0E10-D47A-4A58D5310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902249-4BB9-3C08-D3EE-09319FBB8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7764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195FAF-B3AF-18D1-8E9E-87D2A55657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805B1D-96F3-D8C0-496D-7B365719F2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6F2C56-545D-04CE-AA28-972230941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91CE85-BCC1-C59F-33B9-D5438645C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33816C-C354-05D7-20F6-B87027AE9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8626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C284C-22B3-2C2A-FE27-F0E4187E1E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627F02-E3CF-14CC-8005-0B42E92FE5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389F2A-F7CE-0A16-4E61-6A9CFE707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09D748-4022-7375-C57B-C5E7351B9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FFDA73-E878-90DD-D291-384CEC2F5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434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5A32B-236D-4E61-608D-7C2F7F3FE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668EC6-AD48-BC33-F5C4-A065147D3D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48B0D6-FB82-15EB-70DF-5A11A6185D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31FA5E-63AA-FDA9-CC9D-3C0BA983F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11DF8A-4EAF-8640-183C-00ADCEF6D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5D7D78-462D-F442-3ED9-32357E0F5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893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081B1-2D7D-6926-6D36-2A56FF1AD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383902-8A8D-722D-256F-F6A871812C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2D369B-DCD5-827C-82D1-7E3A029CED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49FFA5-0050-9D16-25EA-42F37A4042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9547E6-B41B-D3CE-CA1B-F486EAFB12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7B6EC9-FAF8-011A-6376-C910A2F7B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033E96-28B4-9E4E-A209-93D3A6785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72FDD3-892E-3336-A53A-2507654B2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877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4877A-A16E-7C26-0FF0-70FB4AEB4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F1901DF-33FC-8CB6-566A-700F2A2E4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E52C9D-AC56-18AF-0B92-1D6B684C7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EF6D65-F2C6-028B-C2FD-D7E032FDC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528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B39822-0F5C-4570-1496-DE49283CF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D47696-02C3-CB44-2E42-3AF27C68F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A110FA-FB93-488F-48AB-139A1D682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5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2D451-18C6-EE2D-E95E-A7C3259A6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A7E90-EA23-463E-4EBA-635ACF1AFC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A7D414-8A8D-6CC4-01A2-277DACD614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D52710-E3AD-1515-CD80-4AE070597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A36967-B8BC-B00F-104C-E8CF20F77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1BCC2A-E1D5-3F37-3A36-7F7D56AFF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26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C22B2-E13D-6CC3-0D0E-AC200AD10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CDFD2F-E380-B0C0-20C3-DEDF60C942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4BB79B-FFE4-6384-C461-5340CE42AF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192010-9928-C6C4-D2F8-6300A881A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E23444-EA3C-C5E9-DCB6-C5136D834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35F92E-41A5-CEA1-3DC0-BF6D1C958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910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0E4251-EAEE-BC0A-3D74-525DA4B24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3114A4-50E6-66E7-5EFC-9626D36E9C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607271-59B9-1CBD-A886-C14E1D09E4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5A9AF1-7DF9-4A34-9A56-94EA1E502D2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E2D8D7-41D4-FEF4-6066-621475B5D7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6956B-E75B-4BA0-5FEE-36BC78D2B9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D4A672-52C3-4090-A3E7-D374305227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0911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a cancer cell&#10;&#10;Description automatically generated with medium confidence">
            <a:extLst>
              <a:ext uri="{FF2B5EF4-FFF2-40B4-BE49-F238E27FC236}">
                <a16:creationId xmlns:a16="http://schemas.microsoft.com/office/drawing/2014/main" id="{6202E651-9029-E6D1-9E38-E7C9B16A827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0245" y="1311275"/>
            <a:ext cx="5731510" cy="4235450"/>
          </a:xfrm>
          <a:prstGeom prst="rect">
            <a:avLst/>
          </a:prstGeom>
        </p:spPr>
      </p:pic>
      <p:sp>
        <p:nvSpPr>
          <p:cNvPr id="2" name="Text Box 8">
            <a:extLst>
              <a:ext uri="{FF2B5EF4-FFF2-40B4-BE49-F238E27FC236}">
                <a16:creationId xmlns:a16="http://schemas.microsoft.com/office/drawing/2014/main" id="{3D7B8E85-90F1-2181-788E-DD6272EFF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1056" y="5733081"/>
            <a:ext cx="5685155" cy="44659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Figure 5 shows </a:t>
            </a:r>
            <a:r>
              <a:rPr lang="en-GB" sz="1100" i="1" kern="100" dirty="0"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e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xpression of interferon signalling genes in TP53 mutant and wild type samples.</a:t>
            </a:r>
            <a:endParaRPr lang="en-GB" sz="1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B610856-5891-3A71-07F6-EF1AC0DAB159}"/>
              </a:ext>
            </a:extLst>
          </p:cNvPr>
          <p:cNvSpPr txBox="1"/>
          <p:nvPr/>
        </p:nvSpPr>
        <p:spPr>
          <a:xfrm>
            <a:off x="3626318" y="676795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Figure 5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619155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3:40:51Z</dcterms:created>
  <dcterms:modified xsi:type="dcterms:W3CDTF">2025-10-30T16:11:10Z</dcterms:modified>
</cp:coreProperties>
</file>